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9472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94BB6C-EA33-4982-B277-E4A22D9BD78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73D733-2016-443D-8FFA-BE42DF2900D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1395DC-FDEB-4E1C-8F2D-BD0989F5C6E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229184-C851-4DAB-9F4D-9BAF52FBF08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5DB1C8-EA66-4F32-BDA6-E6630412AA3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257191-F992-42AE-9F2B-B3C91F8157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0D83E2-A0A0-4726-BD78-9A047967BF2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0D5A05-FBDB-4DA8-8A6E-0C278A652C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A5DB0C-15F0-4E73-A1E1-578F212FF5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9EF3B2-66C0-4386-B1C5-995D8AEC98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6AC2D4-3CEB-43BF-8649-A01DA4E3A3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406102-8409-452F-9450-3FB2E6306E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5EDBAF4-199E-4B99-8016-77642F03FAB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428760" y="285840"/>
          <a:ext cx="3429000" cy="4143240"/>
        </p:xfrm>
        <a:graphic>
          <a:graphicData uri="http://schemas.openxmlformats.org/drawingml/2006/table">
            <a:tbl>
              <a:tblPr/>
              <a:tblGrid>
                <a:gridCol w="995400"/>
                <a:gridCol w="2433600"/>
              </a:tblGrid>
              <a:tr h="137880">
                <a:tc gridSpan="2"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able S3. Primers used in 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3824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rimer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equenc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824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0390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-ggtttgggcatggacggtattgt-3'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0390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-aattatgcgcgcaatggcaccc-3'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0483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-atgttggtgagcccttgcaccaggc-3'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0483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-tcctcatgtaccctcggtatcgg-3'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0584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-atgcggccgcactaccgggcaattagaa-3'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0584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-atgcggccgccactcctgttgtttca-3'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0634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-acgcggccgccgatgaatagcttat-3'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0634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-atgcggccgctgattctcgtaaaggct-3'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0901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-gctctagaggagtttctgtcaaggagg-3'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0901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-ggttccatagtcaactcctctagagtgc-3'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0901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F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-gcggatcctcatgcctcaaagac-3'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0901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R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-cggcatgcccttaatagtgcaaatg-3'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0992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-cgactgaaaaaccaccgatcc-3'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0992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-agcggtatggtgattgccgaca-3'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1647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-tagcggccgcgattatccatatttc-3'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1647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-aagcggccgcttaatttgggagtt-3'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1851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-cctctagagtgtctgactgattgagc-3'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1851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-gctctagagtgaagaggtgagagtag-3'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1851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F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-cgggatccagatgtcatttgaattggtcgc-3'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1851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R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-gctctagagtgaagaggtgagagtag-3'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2275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-gctctagaatctccctgtttgcga-3'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2275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-cattctagagctcctcttgc-3'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2678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-actctagacgttttaccgtcagccc-3'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2678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-cggatctagaatgcccagtacttac-3'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2874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-aagcggccgcgatctccttgctccaa-3'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2874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-gtgcggccgcgagatttgtgttttcc-3'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2874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F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-cgggatccggagtagagcaatgaat-3'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2874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R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'-gctctagagcattcgaggcagagaaatc-3'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8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3-04T12:57:45Z</dcterms:created>
  <dc:creator> 平田源内</dc:creator>
  <dc:description/>
  <dc:language>en-US</dc:language>
  <cp:lastModifiedBy>MiyakeMasaki</cp:lastModifiedBy>
  <dcterms:modified xsi:type="dcterms:W3CDTF">2010-03-02T01:34:14Z</dcterms:modified>
  <cp:revision>103</cp:revision>
  <dc:subject/>
  <dc:title>スライド 1</dc:title>
</cp:coreProperties>
</file>